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docProps/core.xml" ContentType="application/vnd.openxmlformats-package.core-properties+xml"/>
  <Default Extension="png" ContentType="image/png"/>
  <Default Extension="bin" ContentType="application/vnd.openxmlformats-officedocument.oleObject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emf" ContentType="image/x-emf"/>
  <Default Extension="jpeg" ContentType="image/jpeg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6" r:id="rId2"/>
    <p:sldId id="278" r:id="rId3"/>
    <p:sldId id="272" r:id="rId4"/>
    <p:sldId id="277" r:id="rId5"/>
    <p:sldId id="28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94" y="-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image" Target="../media/image24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image" Target="../media/image2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815057-7996-4609-8E4D-AEA4928EAC70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EA1057-7071-45C8-9093-62DD9DCC0E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6637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EA1057-7071-45C8-9093-62DD9DCC0E9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354485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EA1057-7071-45C8-9093-62DD9DCC0E9C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8203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b-NO" dirty="0" smtClean="0"/>
              <a:t>CD69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EA1057-7071-45C8-9093-62DD9DCC0E9C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642116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42039B-9C41-4939-B4C8-0EFE6C6A63BC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46887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4838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7219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853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7576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019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0922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73518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8402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5453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1949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1950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204BD-E68E-4796-8092-567A77C16F92}" type="datetimeFigureOut">
              <a:rPr lang="en-GB" smtClean="0"/>
              <a:t>31/05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A354E5-3736-41D9-A467-CC1B676F8C3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88208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6.png"/><Relationship Id="rId3" Type="http://schemas.openxmlformats.org/officeDocument/2006/relationships/notesSlide" Target="../notesSlides/notesSlide2.xml"/><Relationship Id="rId7" Type="http://schemas.openxmlformats.org/officeDocument/2006/relationships/oleObject" Target="../embeddings/oleObject1.bin"/><Relationship Id="rId12" Type="http://schemas.openxmlformats.org/officeDocument/2006/relationships/image" Target="../media/image15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1.png"/><Relationship Id="rId11" Type="http://schemas.openxmlformats.org/officeDocument/2006/relationships/image" Target="../media/image14.png"/><Relationship Id="rId5" Type="http://schemas.openxmlformats.org/officeDocument/2006/relationships/image" Target="../media/image10.png"/><Relationship Id="rId10" Type="http://schemas.openxmlformats.org/officeDocument/2006/relationships/image" Target="../media/image13.png"/><Relationship Id="rId4" Type="http://schemas.openxmlformats.org/officeDocument/2006/relationships/image" Target="../media/image9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5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24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6.bin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27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26.emf"/><Relationship Id="rId4" Type="http://schemas.openxmlformats.org/officeDocument/2006/relationships/oleObject" Target="../embeddings/oleObject4.bin"/><Relationship Id="rId9" Type="http://schemas.openxmlformats.org/officeDocument/2006/relationships/image" Target="../media/image2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2311" y="1207097"/>
            <a:ext cx="1294286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0071" y="1207097"/>
            <a:ext cx="1294286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50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4480" y="1202879"/>
            <a:ext cx="1268571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Rectangle 8"/>
          <p:cNvSpPr/>
          <p:nvPr/>
        </p:nvSpPr>
        <p:spPr>
          <a:xfrm>
            <a:off x="2986821" y="1083986"/>
            <a:ext cx="50526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sti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4023840" y="969685"/>
            <a:ext cx="107433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nb-NO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ynabeads</a:t>
            </a:r>
            <a:r>
              <a:rPr lang="nb-NO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nb-NO" altLang="zh-CN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nb-NO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nb-NO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3/CD28</a:t>
            </a:r>
            <a:endParaRPr lang="nb-NO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2834607" y="2087719"/>
            <a:ext cx="4667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17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4122367" y="2087719"/>
            <a:ext cx="4667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7.2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6081419" y="1676658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8.0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/>
          <p:cNvSpPr/>
          <p:nvPr/>
        </p:nvSpPr>
        <p:spPr>
          <a:xfrm rot="16200000">
            <a:off x="1866334" y="1786234"/>
            <a:ext cx="12827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CM+CD19+CD14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>
            <a:off x="3133758" y="2619598"/>
            <a:ext cx="1908000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5"/>
          <p:cNvSpPr/>
          <p:nvPr/>
        </p:nvSpPr>
        <p:spPr>
          <a:xfrm>
            <a:off x="2701710" y="2505722"/>
            <a:ext cx="526106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5776947" y="2607862"/>
            <a:ext cx="792000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5449674" y="2493986"/>
            <a:ext cx="441146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4939144" y="2210829"/>
            <a:ext cx="432048" cy="0"/>
          </a:xfrm>
          <a:prstGeom prst="straightConnector1">
            <a:avLst/>
          </a:prstGeom>
          <a:ln w="28575">
            <a:solidFill>
              <a:srgbClr val="C0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 6"/>
          <p:cNvSpPr/>
          <p:nvPr/>
        </p:nvSpPr>
        <p:spPr>
          <a:xfrm>
            <a:off x="844745" y="5661248"/>
            <a:ext cx="748883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ynabead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CD3/CD28 provided specific activating signal to T cells in PBMCs culture system. Total PBMCs pre-stained with CFSE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d with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ynabead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-CD3/CD28 for five days.  Gated o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FSE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M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liferating cells.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-stained PBMCs were stimulated with anti-CD3/CD28 in presence of different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otype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692183" y="1357860"/>
            <a:ext cx="1080000" cy="109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/>
          <p:cNvSpPr/>
          <p:nvPr/>
        </p:nvSpPr>
        <p:spPr>
          <a:xfrm>
            <a:off x="3975743" y="1365060"/>
            <a:ext cx="1080000" cy="109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5515629" y="1365060"/>
            <a:ext cx="1080000" cy="109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Rectangle 21"/>
          <p:cNvSpPr/>
          <p:nvPr/>
        </p:nvSpPr>
        <p:spPr>
          <a:xfrm>
            <a:off x="1763688" y="899320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Rectangle 22"/>
          <p:cNvSpPr/>
          <p:nvPr/>
        </p:nvSpPr>
        <p:spPr>
          <a:xfrm>
            <a:off x="1823677" y="3415852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2226341" y="5186626"/>
            <a:ext cx="5261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/>
          <p:cNvCxnSpPr/>
          <p:nvPr/>
        </p:nvCxnSpPr>
        <p:spPr>
          <a:xfrm>
            <a:off x="2572785" y="3633504"/>
            <a:ext cx="28757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/>
          <p:cNvSpPr/>
          <p:nvPr/>
        </p:nvSpPr>
        <p:spPr>
          <a:xfrm>
            <a:off x="3547233" y="3387283"/>
            <a:ext cx="10967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CD3/CD28</a:t>
            </a:r>
          </a:p>
        </p:txBody>
      </p:sp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8271" y="3861048"/>
            <a:ext cx="1285063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3334" y="3861048"/>
            <a:ext cx="1285063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4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58397" y="3861048"/>
            <a:ext cx="1285063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5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55548" y="3861048"/>
            <a:ext cx="1285063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1" name="Rectangle 30"/>
          <p:cNvSpPr/>
          <p:nvPr/>
        </p:nvSpPr>
        <p:spPr>
          <a:xfrm>
            <a:off x="2263078" y="3684546"/>
            <a:ext cx="105189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zid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3534744" y="3686462"/>
            <a:ext cx="104387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zid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4847798" y="3684546"/>
            <a:ext cx="102944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zide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free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 rot="16200000">
            <a:off x="1750120" y="4457937"/>
            <a:ext cx="55656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2789023" y="5309736"/>
            <a:ext cx="4428000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36"/>
          <p:cNvSpPr/>
          <p:nvPr/>
        </p:nvSpPr>
        <p:spPr>
          <a:xfrm>
            <a:off x="2490150" y="3965657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4.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3786532" y="3972810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8.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5035266" y="3972810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3.7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6341632" y="3972810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6074573" y="3684545"/>
            <a:ext cx="10967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CD3/CD28</a:t>
            </a:r>
          </a:p>
        </p:txBody>
      </p:sp>
    </p:spTree>
    <p:extLst>
      <p:ext uri="{BB962C8B-B14F-4D97-AF65-F5344CB8AC3E}">
        <p14:creationId xmlns:p14="http://schemas.microsoft.com/office/powerpoint/2010/main" val="17049118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57895" y="5694347"/>
            <a:ext cx="719125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.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staine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CFSE and cultured with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ynabead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-CD3/CD28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us control beads or beads-bound anti-CD100 or anti-CD72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µg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ti-CD100 or anti-CD72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used for 100 Million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ynabead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ating according to the optimal protocol from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rmofisher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 ratios of soluble anti-CD100 and bead-bound anti-CD100 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culated 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=4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P&lt;0.001)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8" name="Group 27"/>
          <p:cNvGrpSpPr/>
          <p:nvPr/>
        </p:nvGrpSpPr>
        <p:grpSpPr>
          <a:xfrm>
            <a:off x="2711191" y="917194"/>
            <a:ext cx="3805025" cy="1440000"/>
            <a:chOff x="1586065" y="2330500"/>
            <a:chExt cx="3805025" cy="1440000"/>
          </a:xfrm>
        </p:grpSpPr>
        <p:pic>
          <p:nvPicPr>
            <p:cNvPr id="29" name="Picture 138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86065" y="2330500"/>
              <a:ext cx="1268571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" name="Picture 139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57053" y="2330500"/>
              <a:ext cx="1268571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1" name="Picture 140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22519" y="2330500"/>
              <a:ext cx="1268571" cy="1440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32" name="Rectangle 31"/>
          <p:cNvSpPr/>
          <p:nvPr/>
        </p:nvSpPr>
        <p:spPr>
          <a:xfrm>
            <a:off x="4293521" y="1126986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3.9</a:t>
            </a:r>
          </a:p>
        </p:txBody>
      </p:sp>
      <p:sp>
        <p:nvSpPr>
          <p:cNvPr id="33" name="Rectangle 32"/>
          <p:cNvSpPr/>
          <p:nvPr/>
        </p:nvSpPr>
        <p:spPr>
          <a:xfrm>
            <a:off x="5523118" y="1126986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5.3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3018881" y="1126986"/>
            <a:ext cx="4315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7.0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2711190" y="687187"/>
            <a:ext cx="126450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ead-bound </a:t>
            </a:r>
          </a:p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CD100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3967116" y="687187"/>
            <a:ext cx="126450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ead-bound </a:t>
            </a:r>
          </a:p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ti-CD72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3450410" y="454966"/>
            <a:ext cx="241953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ynabeads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i-CD3/CD28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Straight Arrow Connector 37"/>
          <p:cNvCxnSpPr/>
          <p:nvPr/>
        </p:nvCxnSpPr>
        <p:spPr>
          <a:xfrm>
            <a:off x="3229161" y="2362438"/>
            <a:ext cx="3168000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/>
          <p:cNvSpPr/>
          <p:nvPr/>
        </p:nvSpPr>
        <p:spPr>
          <a:xfrm>
            <a:off x="2706909" y="2234084"/>
            <a:ext cx="526106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 rot="16200000">
            <a:off x="2097127" y="1519327"/>
            <a:ext cx="97334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ells (Max%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" name="Objec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240513"/>
              </p:ext>
            </p:extLst>
          </p:nvPr>
        </p:nvGraphicFramePr>
        <p:xfrm>
          <a:off x="5867400" y="2747963"/>
          <a:ext cx="1635125" cy="2892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58" name="Prism 6" r:id="rId7" imgW="1963820" imgH="3457839" progId="Prism6.Document">
                  <p:embed/>
                </p:oleObj>
              </mc:Choice>
              <mc:Fallback>
                <p:oleObj name="Prism 6" r:id="rId7" imgW="1963820" imgH="3457839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867400" y="2747963"/>
                        <a:ext cx="1635125" cy="289242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Rectangle 41"/>
          <p:cNvSpPr/>
          <p:nvPr/>
        </p:nvSpPr>
        <p:spPr>
          <a:xfrm>
            <a:off x="1176704" y="520242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Rectangle 43"/>
          <p:cNvSpPr/>
          <p:nvPr/>
        </p:nvSpPr>
        <p:spPr>
          <a:xfrm>
            <a:off x="5251711" y="764132"/>
            <a:ext cx="126450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 beads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/>
          <p:cNvCxnSpPr/>
          <p:nvPr/>
        </p:nvCxnSpPr>
        <p:spPr>
          <a:xfrm>
            <a:off x="3213174" y="701078"/>
            <a:ext cx="2916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5"/>
          <p:cNvPicPr>
            <a:picLocks noChangeAspect="1" noChangeArrowheads="1"/>
          </p:cNvPicPr>
          <p:nvPr/>
        </p:nvPicPr>
        <p:blipFill>
          <a:blip r:embed="rId9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2924" y="2876339"/>
            <a:ext cx="1387225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" name="Picture 6"/>
          <p:cNvPicPr>
            <a:picLocks noChangeAspect="1" noChangeArrowheads="1"/>
          </p:cNvPicPr>
          <p:nvPr/>
        </p:nvPicPr>
        <p:blipFill>
          <a:blip r:embed="rId10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9712" y="4059502"/>
            <a:ext cx="1387225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" name="Picture 7"/>
          <p:cNvPicPr>
            <a:picLocks noChangeAspect="1" noChangeArrowheads="1"/>
          </p:cNvPicPr>
          <p:nvPr/>
        </p:nvPicPr>
        <p:blipFill>
          <a:blip r:embed="rId11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3277" y="2876339"/>
            <a:ext cx="1387225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8"/>
          <p:cNvPicPr>
            <a:picLocks noChangeAspect="1" noChangeArrowheads="1"/>
          </p:cNvPicPr>
          <p:nvPr/>
        </p:nvPicPr>
        <p:blipFill>
          <a:blip r:embed="rId12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94578" y="4059502"/>
            <a:ext cx="1387225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5" name="Picture 9"/>
          <p:cNvPicPr>
            <a:picLocks noChangeAspect="1" noChangeArrowheads="1"/>
          </p:cNvPicPr>
          <p:nvPr/>
        </p:nvPicPr>
        <p:blipFill>
          <a:blip r:embed="rId1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7924" y="2876339"/>
            <a:ext cx="1387225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Picture 10"/>
          <p:cNvPicPr>
            <a:picLocks noChangeAspect="1" noChangeArrowheads="1"/>
          </p:cNvPicPr>
          <p:nvPr/>
        </p:nvPicPr>
        <p:blipFill>
          <a:blip r:embed="rId1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7370" y="4059502"/>
            <a:ext cx="1387225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7" name="Rectangle 26"/>
          <p:cNvSpPr/>
          <p:nvPr/>
        </p:nvSpPr>
        <p:spPr>
          <a:xfrm>
            <a:off x="1087926" y="3244100"/>
            <a:ext cx="1201617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ynabeads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ti-CD3/CD28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+sAnti-CD100</a:t>
            </a:r>
          </a:p>
        </p:txBody>
      </p:sp>
      <p:sp>
        <p:nvSpPr>
          <p:cNvPr id="46" name="Rectangle 45"/>
          <p:cNvSpPr/>
          <p:nvPr/>
        </p:nvSpPr>
        <p:spPr>
          <a:xfrm>
            <a:off x="1074529" y="4492814"/>
            <a:ext cx="122841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ynabeads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ti-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3/CD28/CD100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Arrow Connector 46"/>
          <p:cNvCxnSpPr/>
          <p:nvPr/>
        </p:nvCxnSpPr>
        <p:spPr>
          <a:xfrm>
            <a:off x="2667486" y="5350317"/>
            <a:ext cx="2808000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tangle 47"/>
          <p:cNvSpPr/>
          <p:nvPr/>
        </p:nvSpPr>
        <p:spPr>
          <a:xfrm>
            <a:off x="2274072" y="5251964"/>
            <a:ext cx="526106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3688789" y="2772859"/>
            <a:ext cx="44114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nb-NO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nb-NO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4783475" y="2784004"/>
            <a:ext cx="44114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nb-NO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2579605" y="2784005"/>
            <a:ext cx="44114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D3</a:t>
            </a:r>
          </a:p>
        </p:txBody>
      </p:sp>
      <p:sp>
        <p:nvSpPr>
          <p:cNvPr id="52" name="Rectangle 51"/>
          <p:cNvSpPr/>
          <p:nvPr/>
        </p:nvSpPr>
        <p:spPr>
          <a:xfrm>
            <a:off x="2558923" y="3077081"/>
            <a:ext cx="4667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12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3745842" y="3077081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49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4788186" y="3077081"/>
            <a:ext cx="4667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46 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2556175" y="4316339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.9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3736396" y="4316339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.3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6"/>
          <p:cNvSpPr/>
          <p:nvPr/>
        </p:nvSpPr>
        <p:spPr>
          <a:xfrm>
            <a:off x="4914433" y="4303279"/>
            <a:ext cx="43152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b-NO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6.5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1236693" y="2722449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2311515" y="3017546"/>
            <a:ext cx="973866" cy="977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0" name="Rectangle 59"/>
          <p:cNvSpPr/>
          <p:nvPr/>
        </p:nvSpPr>
        <p:spPr>
          <a:xfrm>
            <a:off x="3412904" y="3017546"/>
            <a:ext cx="973866" cy="977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1" name="Rectangle 60"/>
          <p:cNvSpPr/>
          <p:nvPr/>
        </p:nvSpPr>
        <p:spPr>
          <a:xfrm>
            <a:off x="4492095" y="3017546"/>
            <a:ext cx="973866" cy="977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" name="Rectangle 62"/>
          <p:cNvSpPr/>
          <p:nvPr/>
        </p:nvSpPr>
        <p:spPr>
          <a:xfrm>
            <a:off x="2315369" y="4192513"/>
            <a:ext cx="973866" cy="977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" name="Rectangle 63"/>
          <p:cNvSpPr/>
          <p:nvPr/>
        </p:nvSpPr>
        <p:spPr>
          <a:xfrm>
            <a:off x="3416758" y="4192513"/>
            <a:ext cx="973866" cy="977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tangle 64"/>
          <p:cNvSpPr/>
          <p:nvPr/>
        </p:nvSpPr>
        <p:spPr>
          <a:xfrm>
            <a:off x="4495949" y="4192513"/>
            <a:ext cx="973866" cy="977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23333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7944" y="2484645"/>
            <a:ext cx="1560626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Rectangle 3"/>
          <p:cNvSpPr/>
          <p:nvPr/>
        </p:nvSpPr>
        <p:spPr>
          <a:xfrm rot="16200000">
            <a:off x="4994374" y="3389155"/>
            <a:ext cx="5116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7944" y="1205986"/>
            <a:ext cx="1560626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 rot="16200000">
            <a:off x="4974526" y="2136938"/>
            <a:ext cx="53412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CR7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3420" y="2484645"/>
            <a:ext cx="1560626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Rectangle 8"/>
          <p:cNvSpPr/>
          <p:nvPr/>
        </p:nvSpPr>
        <p:spPr>
          <a:xfrm rot="16200000">
            <a:off x="2078214" y="3380167"/>
            <a:ext cx="5116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57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6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4021" y="1199707"/>
            <a:ext cx="1560626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Rectangle 10"/>
          <p:cNvSpPr/>
          <p:nvPr/>
        </p:nvSpPr>
        <p:spPr>
          <a:xfrm rot="16200000">
            <a:off x="3440858" y="2101672"/>
            <a:ext cx="69762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45RA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 rot="16200000">
            <a:off x="2043170" y="2112893"/>
            <a:ext cx="58221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00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 rot="16200000">
            <a:off x="3530875" y="3390767"/>
            <a:ext cx="5116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56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7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3420" y="1196752"/>
            <a:ext cx="1560626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4021" y="2484645"/>
            <a:ext cx="1560626" cy="16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6" name="Straight Arrow Connector 15"/>
          <p:cNvCxnSpPr/>
          <p:nvPr/>
        </p:nvCxnSpPr>
        <p:spPr>
          <a:xfrm>
            <a:off x="2465296" y="3883593"/>
            <a:ext cx="3996000" cy="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185938" y="3769717"/>
            <a:ext cx="526106" cy="246221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Arrow Connector 18"/>
          <p:cNvCxnSpPr/>
          <p:nvPr/>
        </p:nvCxnSpPr>
        <p:spPr>
          <a:xfrm flipV="1">
            <a:off x="2334276" y="1402689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V="1">
            <a:off x="3796504" y="1402689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/>
          <p:cNvCxnSpPr/>
          <p:nvPr/>
        </p:nvCxnSpPr>
        <p:spPr>
          <a:xfrm flipV="1">
            <a:off x="5244020" y="1402689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/>
          <p:nvPr/>
        </p:nvCxnSpPr>
        <p:spPr>
          <a:xfrm flipV="1">
            <a:off x="2339752" y="2717305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V="1">
            <a:off x="3801980" y="2717305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V="1">
            <a:off x="5249496" y="2717305"/>
            <a:ext cx="0" cy="540000"/>
          </a:xfrm>
          <a:prstGeom prst="straightConnector1">
            <a:avLst/>
          </a:prstGeom>
          <a:ln w="28575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/>
          <p:cNvSpPr/>
          <p:nvPr/>
        </p:nvSpPr>
        <p:spPr>
          <a:xfrm>
            <a:off x="1115616" y="4345780"/>
            <a:ext cx="70567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.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liferating T cell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hibite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CD10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RA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7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57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56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69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enotype. Total PBMC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pre-staine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CFSE and cultured with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ynabead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-CD3/CD28 for five days.  Gated on CD3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M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4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FSE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s the proliferating T cells.</a:t>
            </a:r>
          </a:p>
        </p:txBody>
      </p:sp>
      <p:sp>
        <p:nvSpPr>
          <p:cNvPr id="26" name="Rectangle 25"/>
          <p:cNvSpPr/>
          <p:nvPr/>
        </p:nvSpPr>
        <p:spPr>
          <a:xfrm>
            <a:off x="2464838" y="1357797"/>
            <a:ext cx="1080000" cy="109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/>
          <p:cNvSpPr/>
          <p:nvPr/>
        </p:nvSpPr>
        <p:spPr>
          <a:xfrm>
            <a:off x="2464718" y="2638082"/>
            <a:ext cx="1080000" cy="109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/>
          <p:cNvSpPr/>
          <p:nvPr/>
        </p:nvSpPr>
        <p:spPr>
          <a:xfrm>
            <a:off x="3924048" y="1359818"/>
            <a:ext cx="1080000" cy="109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/>
          <p:cNvSpPr/>
          <p:nvPr/>
        </p:nvSpPr>
        <p:spPr>
          <a:xfrm>
            <a:off x="3923928" y="2640103"/>
            <a:ext cx="1080000" cy="109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30"/>
          <p:cNvSpPr/>
          <p:nvPr/>
        </p:nvSpPr>
        <p:spPr>
          <a:xfrm>
            <a:off x="5373733" y="1359818"/>
            <a:ext cx="1080000" cy="109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 31"/>
          <p:cNvSpPr/>
          <p:nvPr/>
        </p:nvSpPr>
        <p:spPr>
          <a:xfrm>
            <a:off x="5373613" y="2640103"/>
            <a:ext cx="1080000" cy="1098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3601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6371873"/>
              </p:ext>
            </p:extLst>
          </p:nvPr>
        </p:nvGraphicFramePr>
        <p:xfrm>
          <a:off x="3175273" y="1827906"/>
          <a:ext cx="1451275" cy="26183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87" name="Prism 6" r:id="rId3" imgW="1817245" imgH="3274881" progId="Prism6.Document">
                  <p:embed/>
                </p:oleObj>
              </mc:Choice>
              <mc:Fallback>
                <p:oleObj name="Prism 6" r:id="rId3" imgW="1817245" imgH="3274881" progId="Prism6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175273" y="1827906"/>
                        <a:ext cx="1451275" cy="2618384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1074504"/>
              </p:ext>
            </p:extLst>
          </p:nvPr>
        </p:nvGraphicFramePr>
        <p:xfrm>
          <a:off x="4644008" y="1827905"/>
          <a:ext cx="1512168" cy="26183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88" name="Prism 6" r:id="rId5" imgW="1890352" imgH="3274881" progId="Prism6.Document">
                  <p:embed/>
                </p:oleObj>
              </mc:Choice>
              <mc:Fallback>
                <p:oleObj name="Prism 6" r:id="rId5" imgW="1890352" imgH="3274881" progId="Prism6.Document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44008" y="1827905"/>
                        <a:ext cx="1512168" cy="2618385"/>
                      </a:xfrm>
                      <a:prstGeom prst="rect">
                        <a:avLst/>
                      </a:prstGeom>
                      <a:noFill/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1403648" y="4581128"/>
            <a:ext cx="633670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ranscriptional expression level of PLXNB1, PLXNB2 and CD72 in CD10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ating T cells. CD3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4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0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100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s were purified by FACS sorting.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seMea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Average value of reads per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lobase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lionread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all samples (n=12). </a:t>
            </a:r>
          </a:p>
        </p:txBody>
      </p:sp>
    </p:spTree>
    <p:extLst>
      <p:ext uri="{BB962C8B-B14F-4D97-AF65-F5344CB8AC3E}">
        <p14:creationId xmlns:p14="http://schemas.microsoft.com/office/powerpoint/2010/main" val="4099707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Rectangle 5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6961253"/>
              </p:ext>
            </p:extLst>
          </p:nvPr>
        </p:nvGraphicFramePr>
        <p:xfrm>
          <a:off x="1890713" y="1320800"/>
          <a:ext cx="1553632" cy="34176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40" name="Prism 6" r:id="rId4" imgW="1890352" imgH="4143932" progId="Prism6.Document">
                  <p:embed/>
                </p:oleObj>
              </mc:Choice>
              <mc:Fallback>
                <p:oleObj name="Prism 6" r:id="rId4" imgW="1890352" imgH="4143932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90713" y="1320800"/>
                        <a:ext cx="1553632" cy="3417654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Rectangle 7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37" name="Objec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1485966"/>
              </p:ext>
            </p:extLst>
          </p:nvPr>
        </p:nvGraphicFramePr>
        <p:xfrm>
          <a:off x="3367782" y="1320800"/>
          <a:ext cx="1564258" cy="3434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41" name="Prism 6" r:id="rId6" imgW="1890352" imgH="4143932" progId="Prism6.Document">
                  <p:embed/>
                </p:oleObj>
              </mc:Choice>
              <mc:Fallback>
                <p:oleObj name="Prism 6" r:id="rId6" imgW="1890352" imgH="4143932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367782" y="1320800"/>
                        <a:ext cx="1564258" cy="343471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Rectangle 31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41" name="Object 4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434746"/>
              </p:ext>
            </p:extLst>
          </p:nvPr>
        </p:nvGraphicFramePr>
        <p:xfrm>
          <a:off x="5181600" y="1203325"/>
          <a:ext cx="1914525" cy="3578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442" name="Prism 6" r:id="rId8" imgW="2317473" imgH="4317887" progId="Prism6.Document">
                  <p:embed/>
                </p:oleObj>
              </mc:Choice>
              <mc:Fallback>
                <p:oleObj name="Prism 6" r:id="rId8" imgW="2317473" imgH="4317887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81600" y="1203325"/>
                        <a:ext cx="1914525" cy="3578225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" name="Rectangle 42"/>
          <p:cNvSpPr/>
          <p:nvPr/>
        </p:nvSpPr>
        <p:spPr>
          <a:xfrm>
            <a:off x="1547664" y="1321023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5036780" y="1321023"/>
            <a:ext cx="31451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827584" y="5085184"/>
            <a:ext cx="748883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Figure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.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racellular IL-2 and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feron gamma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FNg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ere detected 24 hours after indicated treatments (n=4). 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FSE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BMCs were pre-activated by anti-CD3/CD28 coated beads for 24 hours, and beads were removed afterward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oluble anti-CD100 133-1C6 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added and CFSE on PBMCs was detected 4 days later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 ratios we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culated (n=4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*P&lt;0.000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32050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7A27695CBD29F44888F9031E12CD0E2" ma:contentTypeVersion="7" ma:contentTypeDescription="Create a new document." ma:contentTypeScope="" ma:versionID="cd91567087fc7c6aa6b369d2bfe157a6">
  <xsd:schema xmlns:xsd="http://www.w3.org/2001/XMLSchema" xmlns:p="http://schemas.microsoft.com/office/2006/metadata/properties" xmlns:ns2="bf430173-20b6-4a7f-9ac3-dfa6232a70aa" targetNamespace="http://schemas.microsoft.com/office/2006/metadata/properties" ma:root="true" ma:fieldsID="d7888db2e49799e18ca835ad1e08c429" ns2:_="">
    <xsd:import namespace="bf430173-20b6-4a7f-9ac3-dfa6232a70aa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bf430173-20b6-4a7f-9ac3-dfa6232a70aa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bf430173-20b6-4a7f-9ac3-dfa6232a70aa">Presentation 1.PPTX</DocumentId>
    <TitleName xmlns="bf430173-20b6-4a7f-9ac3-dfa6232a70aa">Presentation 1.PPTX</TitleName>
    <DocumentType xmlns="bf430173-20b6-4a7f-9ac3-dfa6232a70aa">Presentation</DocumentType>
    <StageName xmlns="bf430173-20b6-4a7f-9ac3-dfa6232a70aa" xsi:nil="true"/>
    <Checked_x0020_Out_x0020_To xmlns="bf430173-20b6-4a7f-9ac3-dfa6232a70aa">
      <UserInfo>
        <DisplayName/>
        <AccountId xsi:nil="true"/>
        <AccountType/>
      </UserInfo>
    </Checked_x0020_Out_x0020_To>
    <FileFormat xmlns="bf430173-20b6-4a7f-9ac3-dfa6232a70aa">PPTX</FileFormat>
    <IsDeleted xmlns="bf430173-20b6-4a7f-9ac3-dfa6232a70aa">false</IsDeleted>
  </documentManagement>
</p:properties>
</file>

<file path=customXml/itemProps1.xml><?xml version="1.0" encoding="utf-8"?>
<ds:datastoreItem xmlns:ds="http://schemas.openxmlformats.org/officeDocument/2006/customXml" ds:itemID="{A0E5A39C-F84C-4343-83B6-41B1BDA4823B}"/>
</file>

<file path=customXml/itemProps2.xml><?xml version="1.0" encoding="utf-8"?>
<ds:datastoreItem xmlns:ds="http://schemas.openxmlformats.org/officeDocument/2006/customXml" ds:itemID="{B2198C3A-B8D5-4719-9D81-00CD449B173D}"/>
</file>

<file path=customXml/itemProps3.xml><?xml version="1.0" encoding="utf-8"?>
<ds:datastoreItem xmlns:ds="http://schemas.openxmlformats.org/officeDocument/2006/customXml" ds:itemID="{3C72FFB7-B69A-469F-B450-A1C3E35B6B9B}"/>
</file>

<file path=docProps/app.xml><?xml version="1.0" encoding="utf-8"?>
<Properties xmlns="http://schemas.openxmlformats.org/officeDocument/2006/extended-properties" xmlns:vt="http://schemas.openxmlformats.org/officeDocument/2006/docPropsVTypes">
  <TotalTime>3532</TotalTime>
  <Words>348</Words>
  <Application>Microsoft Office PowerPoint</Application>
  <PresentationFormat>On-screen Show (4:3)</PresentationFormat>
  <Paragraphs>69</Paragraphs>
  <Slides>5</Slides>
  <Notes>4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7" baseType="lpstr">
      <vt:lpstr>Office Them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etet i Osl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g Xiaojun</dc:creator>
  <cp:lastModifiedBy>Jiang Xiaojun</cp:lastModifiedBy>
  <cp:revision>281</cp:revision>
  <dcterms:created xsi:type="dcterms:W3CDTF">2016-11-14T12:23:25Z</dcterms:created>
  <dcterms:modified xsi:type="dcterms:W3CDTF">2017-05-31T07:29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7A27695CBD29F44888F9031E12CD0E2</vt:lpwstr>
  </property>
</Properties>
</file>